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09913477415278"/>
          <c:y val="3.1562863216920041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24(-) (n=11)</c:v>
          </c:tx>
          <c:xVal>
            <c:numRef>
              <c:f>Sheet10!$A$46:$A$61</c:f>
              <c:numCache>
                <c:formatCode>General</c:formatCode>
                <c:ptCount val="16"/>
                <c:pt idx="0">
                  <c:v>0</c:v>
                </c:pt>
                <c:pt idx="1">
                  <c:v>7.0684931506849313</c:v>
                </c:pt>
                <c:pt idx="2">
                  <c:v>9.1726027397260275</c:v>
                </c:pt>
                <c:pt idx="3">
                  <c:v>9.1726027397260275</c:v>
                </c:pt>
                <c:pt idx="4">
                  <c:v>11.243835616438357</c:v>
                </c:pt>
                <c:pt idx="5">
                  <c:v>16.109589041095891</c:v>
                </c:pt>
                <c:pt idx="6">
                  <c:v>16.109589041095891</c:v>
                </c:pt>
                <c:pt idx="7">
                  <c:v>17.556164383561644</c:v>
                </c:pt>
                <c:pt idx="8">
                  <c:v>17.556164383561644</c:v>
                </c:pt>
                <c:pt idx="9">
                  <c:v>22.257534246575343</c:v>
                </c:pt>
                <c:pt idx="10">
                  <c:v>22.257534246575343</c:v>
                </c:pt>
                <c:pt idx="11">
                  <c:v>25.052054794520551</c:v>
                </c:pt>
                <c:pt idx="12">
                  <c:v>26.597260273972601</c:v>
                </c:pt>
                <c:pt idx="13">
                  <c:v>28.504109589041093</c:v>
                </c:pt>
                <c:pt idx="14">
                  <c:v>45.764383561643832</c:v>
                </c:pt>
                <c:pt idx="15">
                  <c:v>104.94246575342467</c:v>
                </c:pt>
              </c:numCache>
            </c:numRef>
          </c:xVal>
          <c:yVal>
            <c:numRef>
              <c:f>Sheet10!$B$46:$B$61</c:f>
              <c:numCache>
                <c:formatCode>General</c:formatCode>
                <c:ptCount val="1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</c:v>
                </c:pt>
                <c:pt idx="4">
                  <c:v>0.9</c:v>
                </c:pt>
                <c:pt idx="5">
                  <c:v>0.9</c:v>
                </c:pt>
                <c:pt idx="6">
                  <c:v>0.78749999999999998</c:v>
                </c:pt>
                <c:pt idx="7">
                  <c:v>0.78749999999999998</c:v>
                </c:pt>
                <c:pt idx="8">
                  <c:v>0.67499999999999993</c:v>
                </c:pt>
                <c:pt idx="9">
                  <c:v>0.67499999999999993</c:v>
                </c:pt>
                <c:pt idx="10">
                  <c:v>0.5625</c:v>
                </c:pt>
                <c:pt idx="11">
                  <c:v>0.5625</c:v>
                </c:pt>
                <c:pt idx="12">
                  <c:v>0.5625</c:v>
                </c:pt>
                <c:pt idx="13">
                  <c:v>0.5625</c:v>
                </c:pt>
                <c:pt idx="14">
                  <c:v>0.5625</c:v>
                </c:pt>
                <c:pt idx="15">
                  <c:v>0.5625</c:v>
                </c:pt>
              </c:numCache>
            </c:numRef>
          </c:yVal>
          <c:smooth val="0"/>
        </c:ser>
        <c:ser>
          <c:idx val="1"/>
          <c:order val="1"/>
          <c:tx>
            <c:v>CD24(+) (n=6)</c:v>
          </c:tx>
          <c:xVal>
            <c:numLit>
              <c:formatCode>General</c:formatCode>
              <c:ptCount val="12"/>
              <c:pt idx="0">
                <c:v>0</c:v>
              </c:pt>
              <c:pt idx="1">
                <c:v>4.9643835616438361</c:v>
              </c:pt>
              <c:pt idx="2">
                <c:v>4.9643835616438361</c:v>
              </c:pt>
              <c:pt idx="3">
                <c:v>6.5753424657534243</c:v>
              </c:pt>
              <c:pt idx="4">
                <c:v>12.065753424657533</c:v>
              </c:pt>
              <c:pt idx="5">
                <c:v>12.065753424657533</c:v>
              </c:pt>
              <c:pt idx="6">
                <c:v>26.794520547945204</c:v>
              </c:pt>
              <c:pt idx="7">
                <c:v>26.794520547945204</c:v>
              </c:pt>
              <c:pt idx="8">
                <c:v>31.791780821917811</c:v>
              </c:pt>
              <c:pt idx="9">
                <c:v>31.791780821917811</c:v>
              </c:pt>
              <c:pt idx="10">
                <c:v>41.095890410958901</c:v>
              </c:pt>
              <c:pt idx="11">
                <c:v>41.095890410958901</c:v>
              </c:pt>
            </c:numLit>
          </c:xVal>
          <c:yVal>
            <c:numLit>
              <c:formatCode>General</c:formatCode>
              <c:ptCount val="12"/>
              <c:pt idx="0">
                <c:v>1</c:v>
              </c:pt>
              <c:pt idx="1">
                <c:v>1</c:v>
              </c:pt>
              <c:pt idx="2">
                <c:v>0.83333333333333337</c:v>
              </c:pt>
              <c:pt idx="3">
                <c:v>0.83333333333333337</c:v>
              </c:pt>
              <c:pt idx="4">
                <c:v>0.83333333333333337</c:v>
              </c:pt>
              <c:pt idx="5">
                <c:v>0.625</c:v>
              </c:pt>
              <c:pt idx="6">
                <c:v>0.625</c:v>
              </c:pt>
              <c:pt idx="7">
                <c:v>0.41666666666666669</c:v>
              </c:pt>
              <c:pt idx="8">
                <c:v>0.41666666666666669</c:v>
              </c:pt>
              <c:pt idx="9">
                <c:v>0.20833333333333334</c:v>
              </c:pt>
              <c:pt idx="10">
                <c:v>0.20833333333333334</c:v>
              </c:pt>
              <c:pt idx="11">
                <c:v>0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2742656"/>
        <c:axId val="102749312"/>
      </c:scatterChart>
      <c:valAx>
        <c:axId val="102742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2749312"/>
        <c:crosses val="autoZero"/>
        <c:crossBetween val="midCat"/>
      </c:valAx>
      <c:valAx>
        <c:axId val="10274931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102742656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45842820927794964"/>
          <c:y val="0.17048786089238846"/>
          <c:w val="0.48386778345949549"/>
          <c:h val="0.190030591003710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835338291046958E-2"/>
          <c:y val="4.6260498687664041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XCR4(-) (n=9)</c:v>
          </c:tx>
          <c:xVal>
            <c:numRef>
              <c:f>Sheet14!$A$44:$A$56</c:f>
              <c:numCache>
                <c:formatCode>General</c:formatCode>
                <c:ptCount val="13"/>
                <c:pt idx="0">
                  <c:v>0</c:v>
                </c:pt>
                <c:pt idx="1">
                  <c:v>6.5753424657534243</c:v>
                </c:pt>
                <c:pt idx="2">
                  <c:v>7.0684931506849313</c:v>
                </c:pt>
                <c:pt idx="3">
                  <c:v>11.243835616438357</c:v>
                </c:pt>
                <c:pt idx="4">
                  <c:v>12.065753424657533</c:v>
                </c:pt>
                <c:pt idx="5">
                  <c:v>12.065753424657533</c:v>
                </c:pt>
                <c:pt idx="6">
                  <c:v>16.109589041095891</c:v>
                </c:pt>
                <c:pt idx="7">
                  <c:v>16.109589041095891</c:v>
                </c:pt>
                <c:pt idx="8">
                  <c:v>17.556164383561644</c:v>
                </c:pt>
                <c:pt idx="9">
                  <c:v>17.556164383561644</c:v>
                </c:pt>
                <c:pt idx="10">
                  <c:v>26.597260273972601</c:v>
                </c:pt>
                <c:pt idx="11">
                  <c:v>28.504109589041093</c:v>
                </c:pt>
                <c:pt idx="12">
                  <c:v>104.94246575342467</c:v>
                </c:pt>
              </c:numCache>
            </c:numRef>
          </c:xVal>
          <c:yVal>
            <c:numRef>
              <c:f>Sheet14!$B$44:$B$56</c:f>
              <c:numCache>
                <c:formatCode>General</c:formatCode>
                <c:ptCount val="1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83333333333333337</c:v>
                </c:pt>
                <c:pt idx="6">
                  <c:v>0.83333333333333337</c:v>
                </c:pt>
                <c:pt idx="7">
                  <c:v>0.66666666666666674</c:v>
                </c:pt>
                <c:pt idx="8">
                  <c:v>0.66666666666666674</c:v>
                </c:pt>
                <c:pt idx="9">
                  <c:v>0.5</c:v>
                </c:pt>
                <c:pt idx="10">
                  <c:v>0.5</c:v>
                </c:pt>
                <c:pt idx="11">
                  <c:v>0.5</c:v>
                </c:pt>
                <c:pt idx="12">
                  <c:v>0.5</c:v>
                </c:pt>
              </c:numCache>
            </c:numRef>
          </c:yVal>
          <c:smooth val="0"/>
        </c:ser>
        <c:ser>
          <c:idx val="1"/>
          <c:order val="1"/>
          <c:tx>
            <c:v>CXCR4(+) (n=8)</c:v>
          </c:tx>
          <c:xVal>
            <c:numLit>
              <c:formatCode>General</c:formatCode>
              <c:ptCount val="15"/>
              <c:pt idx="0">
                <c:v>0</c:v>
              </c:pt>
              <c:pt idx="1">
                <c:v>4.9643835616438361</c:v>
              </c:pt>
              <c:pt idx="2">
                <c:v>4.9643835616438361</c:v>
              </c:pt>
              <c:pt idx="3">
                <c:v>9.1726027397260275</c:v>
              </c:pt>
              <c:pt idx="4">
                <c:v>9.1726027397260275</c:v>
              </c:pt>
              <c:pt idx="5">
                <c:v>22.257534246575343</c:v>
              </c:pt>
              <c:pt idx="6">
                <c:v>22.257534246575343</c:v>
              </c:pt>
              <c:pt idx="7">
                <c:v>25.052054794520551</c:v>
              </c:pt>
              <c:pt idx="8">
                <c:v>26.794520547945204</c:v>
              </c:pt>
              <c:pt idx="9">
                <c:v>26.794520547945204</c:v>
              </c:pt>
              <c:pt idx="10">
                <c:v>31.791780821917811</c:v>
              </c:pt>
              <c:pt idx="11">
                <c:v>31.791780821917811</c:v>
              </c:pt>
              <c:pt idx="12">
                <c:v>41.095890410958901</c:v>
              </c:pt>
              <c:pt idx="13">
                <c:v>41.095890410958901</c:v>
              </c:pt>
              <c:pt idx="14">
                <c:v>45.764383561643832</c:v>
              </c:pt>
            </c:numLit>
          </c:xVal>
          <c:yVal>
            <c:numLit>
              <c:formatCode>General</c:formatCode>
              <c:ptCount val="15"/>
              <c:pt idx="0">
                <c:v>1</c:v>
              </c:pt>
              <c:pt idx="1">
                <c:v>1</c:v>
              </c:pt>
              <c:pt idx="2">
                <c:v>0.875</c:v>
              </c:pt>
              <c:pt idx="3">
                <c:v>0.875</c:v>
              </c:pt>
              <c:pt idx="4">
                <c:v>0.75</c:v>
              </c:pt>
              <c:pt idx="5">
                <c:v>0.75</c:v>
              </c:pt>
              <c:pt idx="6">
                <c:v>0.625</c:v>
              </c:pt>
              <c:pt idx="7">
                <c:v>0.625</c:v>
              </c:pt>
              <c:pt idx="8">
                <c:v>0.625</c:v>
              </c:pt>
              <c:pt idx="9">
                <c:v>0.46875</c:v>
              </c:pt>
              <c:pt idx="10">
                <c:v>0.46875</c:v>
              </c:pt>
              <c:pt idx="11">
                <c:v>0.3125</c:v>
              </c:pt>
              <c:pt idx="12">
                <c:v>0.3125</c:v>
              </c:pt>
              <c:pt idx="13">
                <c:v>0.15625</c:v>
              </c:pt>
              <c:pt idx="14">
                <c:v>0.15625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722368"/>
        <c:axId val="103740544"/>
      </c:scatterChart>
      <c:valAx>
        <c:axId val="103722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3740544"/>
        <c:crosses val="autoZero"/>
        <c:crossBetween val="midCat"/>
      </c:valAx>
      <c:valAx>
        <c:axId val="10374054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103722368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42846402952224527"/>
          <c:y val="0.17465452755905511"/>
          <c:w val="0.48576134183288944"/>
          <c:h val="0.2206151152300160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83550893347634"/>
          <c:y val="3.9141535213370514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133(-)　(n=12)</c:v>
          </c:tx>
          <c:xVal>
            <c:numRef>
              <c:f>Sheet16!$A$47:$A$64</c:f>
              <c:numCache>
                <c:formatCode>General</c:formatCode>
                <c:ptCount val="18"/>
                <c:pt idx="0">
                  <c:v>0</c:v>
                </c:pt>
                <c:pt idx="1">
                  <c:v>6.5753424657534243</c:v>
                </c:pt>
                <c:pt idx="2">
                  <c:v>9.1726027397260275</c:v>
                </c:pt>
                <c:pt idx="3">
                  <c:v>9.1726027397260275</c:v>
                </c:pt>
                <c:pt idx="4">
                  <c:v>11.243835616438357</c:v>
                </c:pt>
                <c:pt idx="5">
                  <c:v>16.109589041095891</c:v>
                </c:pt>
                <c:pt idx="6">
                  <c:v>16.109589041095891</c:v>
                </c:pt>
                <c:pt idx="7">
                  <c:v>22.257534246575343</c:v>
                </c:pt>
                <c:pt idx="8">
                  <c:v>22.257534246575343</c:v>
                </c:pt>
                <c:pt idx="9">
                  <c:v>25.052054794520551</c:v>
                </c:pt>
                <c:pt idx="10">
                  <c:v>26.597260273972601</c:v>
                </c:pt>
                <c:pt idx="11">
                  <c:v>26.794520547945204</c:v>
                </c:pt>
                <c:pt idx="12">
                  <c:v>26.794520547945204</c:v>
                </c:pt>
                <c:pt idx="13">
                  <c:v>28.504109589041093</c:v>
                </c:pt>
                <c:pt idx="14">
                  <c:v>41.095890410958901</c:v>
                </c:pt>
                <c:pt idx="15">
                  <c:v>41.095890410958901</c:v>
                </c:pt>
                <c:pt idx="16">
                  <c:v>45.764383561643832</c:v>
                </c:pt>
                <c:pt idx="17">
                  <c:v>104.94246575342467</c:v>
                </c:pt>
              </c:numCache>
            </c:numRef>
          </c:xVal>
          <c:yVal>
            <c:numRef>
              <c:f>Sheet16!$B$47:$B$64</c:f>
              <c:numCache>
                <c:formatCode>General</c:formatCode>
                <c:ptCount val="1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0909090909090906</c:v>
                </c:pt>
                <c:pt idx="4">
                  <c:v>0.90909090909090906</c:v>
                </c:pt>
                <c:pt idx="5">
                  <c:v>0.90909090909090906</c:v>
                </c:pt>
                <c:pt idx="6">
                  <c:v>0.80808080808080807</c:v>
                </c:pt>
                <c:pt idx="7">
                  <c:v>0.80808080808080807</c:v>
                </c:pt>
                <c:pt idx="8">
                  <c:v>0.70707070707070707</c:v>
                </c:pt>
                <c:pt idx="9">
                  <c:v>0.70707070707070707</c:v>
                </c:pt>
                <c:pt idx="10">
                  <c:v>0.70707070707070707</c:v>
                </c:pt>
                <c:pt idx="11">
                  <c:v>0.70707070707070707</c:v>
                </c:pt>
                <c:pt idx="12">
                  <c:v>0.56565656565656564</c:v>
                </c:pt>
                <c:pt idx="13">
                  <c:v>0.56565656565656564</c:v>
                </c:pt>
                <c:pt idx="14">
                  <c:v>0.56565656565656564</c:v>
                </c:pt>
                <c:pt idx="15">
                  <c:v>0.37710437710437711</c:v>
                </c:pt>
                <c:pt idx="16">
                  <c:v>0.37710437710437711</c:v>
                </c:pt>
                <c:pt idx="17">
                  <c:v>0.37710437710437711</c:v>
                </c:pt>
              </c:numCache>
            </c:numRef>
          </c:yVal>
          <c:smooth val="0"/>
        </c:ser>
        <c:ser>
          <c:idx val="1"/>
          <c:order val="1"/>
          <c:tx>
            <c:v>CD133(+)　(n=5)</c:v>
          </c:tx>
          <c:xVal>
            <c:numLit>
              <c:formatCode>General</c:formatCode>
              <c:ptCount val="10"/>
              <c:pt idx="0">
                <c:v>0</c:v>
              </c:pt>
              <c:pt idx="1">
                <c:v>4.9643835616438361</c:v>
              </c:pt>
              <c:pt idx="2">
                <c:v>4.9643835616438361</c:v>
              </c:pt>
              <c:pt idx="3">
                <c:v>7.0684931506849313</c:v>
              </c:pt>
              <c:pt idx="4">
                <c:v>12.065753424657533</c:v>
              </c:pt>
              <c:pt idx="5">
                <c:v>12.065753424657533</c:v>
              </c:pt>
              <c:pt idx="6">
                <c:v>17.556164383561644</c:v>
              </c:pt>
              <c:pt idx="7">
                <c:v>17.556164383561644</c:v>
              </c:pt>
              <c:pt idx="8">
                <c:v>31.791780821917811</c:v>
              </c:pt>
              <c:pt idx="9">
                <c:v>31.791780821917811</c:v>
              </c:pt>
            </c:numLit>
          </c:xVal>
          <c:yVal>
            <c:numLit>
              <c:formatCode>General</c:formatCode>
              <c:ptCount val="10"/>
              <c:pt idx="0">
                <c:v>1</c:v>
              </c:pt>
              <c:pt idx="1">
                <c:v>1</c:v>
              </c:pt>
              <c:pt idx="2">
                <c:v>0.8</c:v>
              </c:pt>
              <c:pt idx="3">
                <c:v>0.8</c:v>
              </c:pt>
              <c:pt idx="4">
                <c:v>0.8</c:v>
              </c:pt>
              <c:pt idx="5">
                <c:v>0.53333333333333333</c:v>
              </c:pt>
              <c:pt idx="6">
                <c:v>0.53333333333333333</c:v>
              </c:pt>
              <c:pt idx="7">
                <c:v>0.26666666666666666</c:v>
              </c:pt>
              <c:pt idx="8">
                <c:v>0.26666666666666666</c:v>
              </c:pt>
              <c:pt idx="9">
                <c:v>0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954688"/>
        <c:axId val="103956480"/>
      </c:scatterChart>
      <c:valAx>
        <c:axId val="10395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3956480"/>
        <c:crosses val="autoZero"/>
        <c:crossBetween val="midCat"/>
      </c:valAx>
      <c:valAx>
        <c:axId val="103956480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103954688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36264880022424417"/>
          <c:y val="0.22465452755905513"/>
          <c:w val="0.54303379413756447"/>
          <c:h val="0.19001956910863171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14701795493556"/>
          <c:y val="4.1248001894500036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ALDH1(-)　(n=6)</c:v>
          </c:tx>
          <c:xVal>
            <c:numRef>
              <c:f>Sheet18!$A$46:$A$56</c:f>
              <c:numCache>
                <c:formatCode>General</c:formatCode>
                <c:ptCount val="11"/>
                <c:pt idx="0">
                  <c:v>0</c:v>
                </c:pt>
                <c:pt idx="1">
                  <c:v>4.9643835616438361</c:v>
                </c:pt>
                <c:pt idx="2">
                  <c:v>4.9643835616438361</c:v>
                </c:pt>
                <c:pt idx="3">
                  <c:v>7.0684931506849313</c:v>
                </c:pt>
                <c:pt idx="4">
                  <c:v>12.065753424657533</c:v>
                </c:pt>
                <c:pt idx="5">
                  <c:v>12.065753424657533</c:v>
                </c:pt>
                <c:pt idx="6">
                  <c:v>17.556164383561644</c:v>
                </c:pt>
                <c:pt idx="7">
                  <c:v>17.556164383561644</c:v>
                </c:pt>
                <c:pt idx="8">
                  <c:v>41.095890410958901</c:v>
                </c:pt>
                <c:pt idx="9">
                  <c:v>41.095890410958901</c:v>
                </c:pt>
                <c:pt idx="10">
                  <c:v>45.764383561643832</c:v>
                </c:pt>
              </c:numCache>
            </c:numRef>
          </c:xVal>
          <c:yVal>
            <c:numRef>
              <c:f>Sheet18!$B$46:$B$56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0.83333333333333337</c:v>
                </c:pt>
                <c:pt idx="3">
                  <c:v>0.83333333333333337</c:v>
                </c:pt>
                <c:pt idx="4">
                  <c:v>0.83333333333333337</c:v>
                </c:pt>
                <c:pt idx="5">
                  <c:v>0.625</c:v>
                </c:pt>
                <c:pt idx="6">
                  <c:v>0.625</c:v>
                </c:pt>
                <c:pt idx="7">
                  <c:v>0.41666666666666669</c:v>
                </c:pt>
                <c:pt idx="8">
                  <c:v>0.41666666666666669</c:v>
                </c:pt>
                <c:pt idx="9">
                  <c:v>0.20833333333333334</c:v>
                </c:pt>
                <c:pt idx="10">
                  <c:v>0.20833333333333334</c:v>
                </c:pt>
              </c:numCache>
            </c:numRef>
          </c:yVal>
          <c:smooth val="0"/>
        </c:ser>
        <c:ser>
          <c:idx val="1"/>
          <c:order val="1"/>
          <c:tx>
            <c:v>ALDH1(+)　(n=11)</c:v>
          </c:tx>
          <c:xVal>
            <c:numLit>
              <c:formatCode>General</c:formatCode>
              <c:ptCount val="17"/>
              <c:pt idx="0">
                <c:v>0</c:v>
              </c:pt>
              <c:pt idx="1">
                <c:v>6.5753424657534243</c:v>
              </c:pt>
              <c:pt idx="2">
                <c:v>9.1726027397260275</c:v>
              </c:pt>
              <c:pt idx="3">
                <c:v>9.1726027397260275</c:v>
              </c:pt>
              <c:pt idx="4">
                <c:v>11.243835616438357</c:v>
              </c:pt>
              <c:pt idx="5">
                <c:v>16.109589041095891</c:v>
              </c:pt>
              <c:pt idx="6">
                <c:v>16.109589041095891</c:v>
              </c:pt>
              <c:pt idx="7">
                <c:v>22.257534246575343</c:v>
              </c:pt>
              <c:pt idx="8">
                <c:v>22.257534246575343</c:v>
              </c:pt>
              <c:pt idx="9">
                <c:v>25.052054794520551</c:v>
              </c:pt>
              <c:pt idx="10">
                <c:v>26.597260273972601</c:v>
              </c:pt>
              <c:pt idx="11">
                <c:v>26.794520547945204</c:v>
              </c:pt>
              <c:pt idx="12">
                <c:v>26.794520547945204</c:v>
              </c:pt>
              <c:pt idx="13">
                <c:v>28.504109589041093</c:v>
              </c:pt>
              <c:pt idx="14">
                <c:v>31.791780821917811</c:v>
              </c:pt>
              <c:pt idx="15">
                <c:v>31.791780821917811</c:v>
              </c:pt>
              <c:pt idx="16">
                <c:v>104.94246575342467</c:v>
              </c:pt>
            </c:numLit>
          </c:xVal>
          <c:yVal>
            <c:numLit>
              <c:formatCode>General</c:formatCode>
              <c:ptCount val="17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0.9</c:v>
              </c:pt>
              <c:pt idx="4">
                <c:v>0.9</c:v>
              </c:pt>
              <c:pt idx="5">
                <c:v>0.9</c:v>
              </c:pt>
              <c:pt idx="6">
                <c:v>0.78749999999999998</c:v>
              </c:pt>
              <c:pt idx="7">
                <c:v>0.78749999999999998</c:v>
              </c:pt>
              <c:pt idx="8">
                <c:v>0.67499999999999993</c:v>
              </c:pt>
              <c:pt idx="9">
                <c:v>0.67499999999999993</c:v>
              </c:pt>
              <c:pt idx="10">
                <c:v>0.67499999999999993</c:v>
              </c:pt>
              <c:pt idx="11">
                <c:v>0.67499999999999993</c:v>
              </c:pt>
              <c:pt idx="12">
                <c:v>0.50624999999999998</c:v>
              </c:pt>
              <c:pt idx="13">
                <c:v>0.50624999999999998</c:v>
              </c:pt>
              <c:pt idx="14">
                <c:v>0.50624999999999998</c:v>
              </c:pt>
              <c:pt idx="15">
                <c:v>0.25312499999999999</c:v>
              </c:pt>
              <c:pt idx="16">
                <c:v>0.25312499999999999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079936"/>
        <c:axId val="41081472"/>
      </c:scatterChart>
      <c:valAx>
        <c:axId val="41079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1081472"/>
        <c:crosses val="autoZero"/>
        <c:crossBetween val="midCat"/>
      </c:valAx>
      <c:valAx>
        <c:axId val="4108147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41079936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42380777923592883"/>
          <c:y val="0.29965452755905514"/>
          <c:w val="0.54698032565814114"/>
          <c:h val="0.2024714846498537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88083284891402"/>
          <c:y val="2.8650327159809249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EpCAM(-)　(n=7)</c:v>
          </c:tx>
          <c:xVal>
            <c:numRef>
              <c:f>Sheet19!$A$45:$A$56</c:f>
              <c:numCache>
                <c:formatCode>General</c:formatCode>
                <c:ptCount val="12"/>
                <c:pt idx="0">
                  <c:v>0</c:v>
                </c:pt>
                <c:pt idx="1">
                  <c:v>4.9643835616438361</c:v>
                </c:pt>
                <c:pt idx="2">
                  <c:v>4.9643835616438361</c:v>
                </c:pt>
                <c:pt idx="3">
                  <c:v>7.0684931506849313</c:v>
                </c:pt>
                <c:pt idx="4">
                  <c:v>11.243835616438357</c:v>
                </c:pt>
                <c:pt idx="5">
                  <c:v>16.109589041095891</c:v>
                </c:pt>
                <c:pt idx="6">
                  <c:v>16.109589041095891</c:v>
                </c:pt>
                <c:pt idx="7">
                  <c:v>22.257534246575343</c:v>
                </c:pt>
                <c:pt idx="8">
                  <c:v>22.257534246575343</c:v>
                </c:pt>
                <c:pt idx="9">
                  <c:v>26.794520547945204</c:v>
                </c:pt>
                <c:pt idx="10">
                  <c:v>26.794520547945204</c:v>
                </c:pt>
                <c:pt idx="11">
                  <c:v>45.764383561643832</c:v>
                </c:pt>
              </c:numCache>
            </c:numRef>
          </c:xVal>
          <c:yVal>
            <c:numRef>
              <c:f>Sheet19!$B$45:$B$56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0.8571428571428571</c:v>
                </c:pt>
                <c:pt idx="3">
                  <c:v>0.8571428571428571</c:v>
                </c:pt>
                <c:pt idx="4">
                  <c:v>0.8571428571428571</c:v>
                </c:pt>
                <c:pt idx="5">
                  <c:v>0.8571428571428571</c:v>
                </c:pt>
                <c:pt idx="6">
                  <c:v>0.64285714285714279</c:v>
                </c:pt>
                <c:pt idx="7">
                  <c:v>0.64285714285714279</c:v>
                </c:pt>
                <c:pt idx="8">
                  <c:v>0.42857142857142855</c:v>
                </c:pt>
                <c:pt idx="9">
                  <c:v>0.42857142857142855</c:v>
                </c:pt>
                <c:pt idx="10">
                  <c:v>0.21428571428571427</c:v>
                </c:pt>
                <c:pt idx="11">
                  <c:v>0.21428571428571427</c:v>
                </c:pt>
              </c:numCache>
            </c:numRef>
          </c:yVal>
          <c:smooth val="0"/>
        </c:ser>
        <c:ser>
          <c:idx val="1"/>
          <c:order val="1"/>
          <c:tx>
            <c:v>EpCAM(+)　(n=10)</c:v>
          </c:tx>
          <c:xVal>
            <c:numLit>
              <c:formatCode>General</c:formatCode>
              <c:ptCount val="16"/>
              <c:pt idx="0">
                <c:v>0</c:v>
              </c:pt>
              <c:pt idx="1">
                <c:v>6.5753424657534243</c:v>
              </c:pt>
              <c:pt idx="2">
                <c:v>9.1726027397260275</c:v>
              </c:pt>
              <c:pt idx="3">
                <c:v>9.1726027397260275</c:v>
              </c:pt>
              <c:pt idx="4">
                <c:v>12.065753424657533</c:v>
              </c:pt>
              <c:pt idx="5">
                <c:v>12.065753424657533</c:v>
              </c:pt>
              <c:pt idx="6">
                <c:v>17.556164383561644</c:v>
              </c:pt>
              <c:pt idx="7">
                <c:v>17.556164383561644</c:v>
              </c:pt>
              <c:pt idx="8">
                <c:v>25.052054794520551</c:v>
              </c:pt>
              <c:pt idx="9">
                <c:v>26.597260273972601</c:v>
              </c:pt>
              <c:pt idx="10">
                <c:v>28.504109589041093</c:v>
              </c:pt>
              <c:pt idx="11">
                <c:v>31.791780821917811</c:v>
              </c:pt>
              <c:pt idx="12">
                <c:v>31.791780821917811</c:v>
              </c:pt>
              <c:pt idx="13">
                <c:v>41.095890410958901</c:v>
              </c:pt>
              <c:pt idx="14">
                <c:v>41.095890410958901</c:v>
              </c:pt>
              <c:pt idx="15">
                <c:v>104.94246575342467</c:v>
              </c:pt>
            </c:numLit>
          </c:xVal>
          <c:yVal>
            <c:numLit>
              <c:formatCode>General</c:formatCode>
              <c:ptCount val="16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0.88888888888888884</c:v>
              </c:pt>
              <c:pt idx="4">
                <c:v>0.88888888888888884</c:v>
              </c:pt>
              <c:pt idx="5">
                <c:v>0.77777777777777768</c:v>
              </c:pt>
              <c:pt idx="6">
                <c:v>0.77777777777777768</c:v>
              </c:pt>
              <c:pt idx="7">
                <c:v>0.66666666666666663</c:v>
              </c:pt>
              <c:pt idx="8">
                <c:v>0.66666666666666663</c:v>
              </c:pt>
              <c:pt idx="9">
                <c:v>0.66666666666666663</c:v>
              </c:pt>
              <c:pt idx="10">
                <c:v>0.66666666666666663</c:v>
              </c:pt>
              <c:pt idx="11">
                <c:v>0.66666666666666663</c:v>
              </c:pt>
              <c:pt idx="12">
                <c:v>0.44444444444444442</c:v>
              </c:pt>
              <c:pt idx="13">
                <c:v>0.44444444444444442</c:v>
              </c:pt>
              <c:pt idx="14">
                <c:v>0.22222222222222221</c:v>
              </c:pt>
              <c:pt idx="15">
                <c:v>0.22222222222222221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312256"/>
        <c:axId val="41313792"/>
      </c:scatterChart>
      <c:valAx>
        <c:axId val="41312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1313792"/>
        <c:crosses val="autoZero"/>
        <c:crossBetween val="midCat"/>
      </c:valAx>
      <c:valAx>
        <c:axId val="4131379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41312256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40722542232556502"/>
          <c:y val="0.24965452755905512"/>
          <c:w val="0.55259100798163918"/>
          <c:h val="0.267011998666814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835338291046958E-2"/>
          <c:y val="4.6260498687664041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44(-)　(n=3)</c:v>
          </c:tx>
          <c:xVal>
            <c:numRef>
              <c:f>Sheet20!$A$49:$A$53</c:f>
              <c:numCache>
                <c:formatCode>General</c:formatCode>
                <c:ptCount val="5"/>
                <c:pt idx="0">
                  <c:v>0</c:v>
                </c:pt>
                <c:pt idx="1">
                  <c:v>6.5753424657534243</c:v>
                </c:pt>
                <c:pt idx="2">
                  <c:v>26.794520547945204</c:v>
                </c:pt>
                <c:pt idx="3">
                  <c:v>26.794520547945204</c:v>
                </c:pt>
                <c:pt idx="4">
                  <c:v>45.764383561643832</c:v>
                </c:pt>
              </c:numCache>
            </c:numRef>
          </c:xVal>
          <c:yVal>
            <c:numRef>
              <c:f>Sheet20!$B$49:$B$53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5</c:v>
                </c:pt>
                <c:pt idx="4">
                  <c:v>0.5</c:v>
                </c:pt>
              </c:numCache>
            </c:numRef>
          </c:yVal>
          <c:smooth val="0"/>
        </c:ser>
        <c:ser>
          <c:idx val="1"/>
          <c:order val="1"/>
          <c:tx>
            <c:v>CD44(+)　(n=14)</c:v>
          </c:tx>
          <c:xVal>
            <c:numLit>
              <c:formatCode>General</c:formatCode>
              <c:ptCount val="23"/>
              <c:pt idx="0">
                <c:v>0</c:v>
              </c:pt>
              <c:pt idx="1">
                <c:v>4.9643835616438361</c:v>
              </c:pt>
              <c:pt idx="2">
                <c:v>4.9643835616438361</c:v>
              </c:pt>
              <c:pt idx="3">
                <c:v>7.0684931506849313</c:v>
              </c:pt>
              <c:pt idx="4">
                <c:v>9.1726027397260275</c:v>
              </c:pt>
              <c:pt idx="5">
                <c:v>9.1726027397260275</c:v>
              </c:pt>
              <c:pt idx="6">
                <c:v>11.243835616438357</c:v>
              </c:pt>
              <c:pt idx="7">
                <c:v>12.065753424657533</c:v>
              </c:pt>
              <c:pt idx="8">
                <c:v>12.065753424657533</c:v>
              </c:pt>
              <c:pt idx="9">
                <c:v>16.109589041095891</c:v>
              </c:pt>
              <c:pt idx="10">
                <c:v>16.109589041095891</c:v>
              </c:pt>
              <c:pt idx="11">
                <c:v>17.556164383561644</c:v>
              </c:pt>
              <c:pt idx="12">
                <c:v>17.556164383561644</c:v>
              </c:pt>
              <c:pt idx="13">
                <c:v>22.257534246575343</c:v>
              </c:pt>
              <c:pt idx="14">
                <c:v>22.257534246575343</c:v>
              </c:pt>
              <c:pt idx="15">
                <c:v>25.052054794520551</c:v>
              </c:pt>
              <c:pt idx="16">
                <c:v>26.597260273972601</c:v>
              </c:pt>
              <c:pt idx="17">
                <c:v>28.504109589041093</c:v>
              </c:pt>
              <c:pt idx="18">
                <c:v>31.791780821917811</c:v>
              </c:pt>
              <c:pt idx="19">
                <c:v>31.791780821917811</c:v>
              </c:pt>
              <c:pt idx="20">
                <c:v>41.095890410958901</c:v>
              </c:pt>
              <c:pt idx="21">
                <c:v>41.095890410958901</c:v>
              </c:pt>
              <c:pt idx="22">
                <c:v>104.94246575342467</c:v>
              </c:pt>
            </c:numLit>
          </c:xVal>
          <c:yVal>
            <c:numLit>
              <c:formatCode>General</c:formatCode>
              <c:ptCount val="23"/>
              <c:pt idx="0">
                <c:v>1</c:v>
              </c:pt>
              <c:pt idx="1">
                <c:v>1</c:v>
              </c:pt>
              <c:pt idx="2">
                <c:v>0.9285714285714286</c:v>
              </c:pt>
              <c:pt idx="3">
                <c:v>0.9285714285714286</c:v>
              </c:pt>
              <c:pt idx="4">
                <c:v>0.9285714285714286</c:v>
              </c:pt>
              <c:pt idx="5">
                <c:v>0.85119047619047628</c:v>
              </c:pt>
              <c:pt idx="6">
                <c:v>0.85119047619047628</c:v>
              </c:pt>
              <c:pt idx="7">
                <c:v>0.85119047619047628</c:v>
              </c:pt>
              <c:pt idx="8">
                <c:v>0.76607142857142863</c:v>
              </c:pt>
              <c:pt idx="9">
                <c:v>0.76607142857142863</c:v>
              </c:pt>
              <c:pt idx="10">
                <c:v>0.68095238095238098</c:v>
              </c:pt>
              <c:pt idx="11">
                <c:v>0.68095238095238098</c:v>
              </c:pt>
              <c:pt idx="12">
                <c:v>0.59583333333333333</c:v>
              </c:pt>
              <c:pt idx="13">
                <c:v>0.59583333333333333</c:v>
              </c:pt>
              <c:pt idx="14">
                <c:v>0.51071428571428568</c:v>
              </c:pt>
              <c:pt idx="15">
                <c:v>0.51071428571428568</c:v>
              </c:pt>
              <c:pt idx="16">
                <c:v>0.51071428571428568</c:v>
              </c:pt>
              <c:pt idx="17">
                <c:v>0.51071428571428568</c:v>
              </c:pt>
              <c:pt idx="18">
                <c:v>0.51071428571428568</c:v>
              </c:pt>
              <c:pt idx="19">
                <c:v>0.34047619047619043</c:v>
              </c:pt>
              <c:pt idx="20">
                <c:v>0.34047619047619043</c:v>
              </c:pt>
              <c:pt idx="21">
                <c:v>0.17023809523809522</c:v>
              </c:pt>
              <c:pt idx="22">
                <c:v>0.17023809523809522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545088"/>
        <c:axId val="42534016"/>
      </c:scatterChart>
      <c:valAx>
        <c:axId val="41545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2534016"/>
        <c:crosses val="autoZero"/>
        <c:crossBetween val="midCat"/>
      </c:valAx>
      <c:valAx>
        <c:axId val="42534016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41545088"/>
        <c:crosses val="autoZero"/>
        <c:crossBetween val="midCat"/>
      </c:valAx>
    </c:plotArea>
    <c:legend>
      <c:legendPos val="r"/>
      <c:legendEntry>
        <c:idx val="0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37138736639694581"/>
          <c:y val="0.26215452755905511"/>
          <c:w val="0.52031678749131538"/>
          <c:h val="0.2398500187476565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764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146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575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765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189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7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711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514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070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872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8101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0D6D8-4C56-476A-88E2-FE56296E99E5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60B28-B1B2-4EB5-A6EF-73C1C637B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035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4606207"/>
              </p:ext>
            </p:extLst>
          </p:nvPr>
        </p:nvGraphicFramePr>
        <p:xfrm>
          <a:off x="3203848" y="1196753"/>
          <a:ext cx="2664296" cy="2232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5677855"/>
              </p:ext>
            </p:extLst>
          </p:nvPr>
        </p:nvGraphicFramePr>
        <p:xfrm>
          <a:off x="3203848" y="3933056"/>
          <a:ext cx="2664296" cy="2173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0431343"/>
              </p:ext>
            </p:extLst>
          </p:nvPr>
        </p:nvGraphicFramePr>
        <p:xfrm>
          <a:off x="395537" y="3933056"/>
          <a:ext cx="2736303" cy="2139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835696" y="5157192"/>
            <a:ext cx="10182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solidFill>
                  <a:srgbClr val="FF0000"/>
                </a:solidFill>
              </a:rPr>
              <a:t>P= 0.0406</a:t>
            </a:r>
            <a:endParaRPr kumimoji="1" lang="ja-JP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712567" y="5013176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661</a:t>
            </a:r>
            <a:endParaRPr kumimoji="1" lang="ja-JP" altLang="en-US" sz="1600" b="1" dirty="0"/>
          </a:p>
        </p:txBody>
      </p:sp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9100446"/>
              </p:ext>
            </p:extLst>
          </p:nvPr>
        </p:nvGraphicFramePr>
        <p:xfrm>
          <a:off x="6084168" y="3933056"/>
          <a:ext cx="2736305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7592887" y="5013176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598</a:t>
            </a:r>
            <a:endParaRPr kumimoji="1" lang="ja-JP" altLang="en-US" sz="1600" b="1" dirty="0"/>
          </a:p>
        </p:txBody>
      </p:sp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444061"/>
              </p:ext>
            </p:extLst>
          </p:nvPr>
        </p:nvGraphicFramePr>
        <p:xfrm>
          <a:off x="395536" y="1196752"/>
          <a:ext cx="2694434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1979712" y="2420888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485</a:t>
            </a:r>
            <a:endParaRPr kumimoji="1" lang="ja-JP" altLang="en-US" sz="1600" b="1" dirty="0"/>
          </a:p>
        </p:txBody>
      </p:sp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8386766"/>
              </p:ext>
            </p:extLst>
          </p:nvPr>
        </p:nvGraphicFramePr>
        <p:xfrm>
          <a:off x="6167957" y="1208745"/>
          <a:ext cx="2849860" cy="22202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7" name="正方形/長方形 16"/>
          <p:cNvSpPr/>
          <p:nvPr/>
        </p:nvSpPr>
        <p:spPr>
          <a:xfrm>
            <a:off x="7668344" y="2492896"/>
            <a:ext cx="91403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 smtClean="0"/>
              <a:t>P= 0.414</a:t>
            </a:r>
            <a:endParaRPr lang="ja-JP" altLang="en-US" sz="16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864967" y="2154342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207</a:t>
            </a:r>
            <a:endParaRPr kumimoji="1" lang="ja-JP" altLang="en-US" sz="1600" b="1" dirty="0"/>
          </a:p>
        </p:txBody>
      </p:sp>
      <p:sp>
        <p:nvSpPr>
          <p:cNvPr id="19" name="正方形/長方形 18"/>
          <p:cNvSpPr/>
          <p:nvPr/>
        </p:nvSpPr>
        <p:spPr>
          <a:xfrm>
            <a:off x="3671063" y="3354377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0" name="正方形/長方形 19"/>
          <p:cNvSpPr/>
          <p:nvPr/>
        </p:nvSpPr>
        <p:spPr>
          <a:xfrm>
            <a:off x="882176" y="3353518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1" name="正方形/長方形 20"/>
          <p:cNvSpPr/>
          <p:nvPr/>
        </p:nvSpPr>
        <p:spPr>
          <a:xfrm>
            <a:off x="6749656" y="3356992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2" name="正方形/長方形 21"/>
          <p:cNvSpPr/>
          <p:nvPr/>
        </p:nvSpPr>
        <p:spPr>
          <a:xfrm>
            <a:off x="3671063" y="6005025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3" name="正方形/長方形 22"/>
          <p:cNvSpPr/>
          <p:nvPr/>
        </p:nvSpPr>
        <p:spPr>
          <a:xfrm>
            <a:off x="899592" y="5990224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4" name="正方形/長方形 23"/>
          <p:cNvSpPr/>
          <p:nvPr/>
        </p:nvSpPr>
        <p:spPr>
          <a:xfrm>
            <a:off x="6623391" y="5991377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</a:t>
            </a:r>
            <a:r>
              <a:rPr lang="en-US" altLang="ja-JP" sz="1200" b="1" dirty="0" smtClean="0"/>
              <a:t>month)</a:t>
            </a:r>
            <a:endParaRPr lang="ja-JP" altLang="en-US" sz="1200" b="1" dirty="0"/>
          </a:p>
        </p:txBody>
      </p:sp>
      <p:sp>
        <p:nvSpPr>
          <p:cNvPr id="25" name="正方形/長方形 24"/>
          <p:cNvSpPr/>
          <p:nvPr/>
        </p:nvSpPr>
        <p:spPr>
          <a:xfrm rot="16200000">
            <a:off x="-232265" y="2123617"/>
            <a:ext cx="978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Survival rate</a:t>
            </a:r>
            <a:endParaRPr lang="ja-JP" altLang="en-US" sz="1200" b="1" dirty="0"/>
          </a:p>
        </p:txBody>
      </p:sp>
      <p:sp>
        <p:nvSpPr>
          <p:cNvPr id="26" name="正方形/長方形 25"/>
          <p:cNvSpPr/>
          <p:nvPr/>
        </p:nvSpPr>
        <p:spPr>
          <a:xfrm rot="16200000">
            <a:off x="-229648" y="4846273"/>
            <a:ext cx="978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Survival rate</a:t>
            </a:r>
            <a:endParaRPr lang="ja-JP" altLang="en-US" sz="1200" b="1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475656" y="1043444"/>
            <a:ext cx="88357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EpCAM</a:t>
            </a:r>
            <a:endParaRPr kumimoji="1" lang="ja-JP" altLang="en-US" b="1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342328" y="1043444"/>
            <a:ext cx="6848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24</a:t>
            </a:r>
            <a:endParaRPr kumimoji="1" lang="ja-JP" altLang="en-US" b="1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366664" y="1052736"/>
            <a:ext cx="6848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44</a:t>
            </a:r>
            <a:endParaRPr kumimoji="1" lang="ja-JP" altLang="en-US" b="1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534016" y="3844220"/>
            <a:ext cx="80182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133</a:t>
            </a:r>
            <a:endParaRPr kumimoji="1" lang="ja-JP" altLang="en-US" b="1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319725" y="3879052"/>
            <a:ext cx="7873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XCR4</a:t>
            </a:r>
            <a:endParaRPr kumimoji="1" lang="ja-JP" altLang="en-US" b="1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320539" y="3947292"/>
            <a:ext cx="83067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ALDH1</a:t>
            </a:r>
            <a:endParaRPr kumimoji="1" lang="ja-JP" altLang="en-US" b="1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146222" y="260648"/>
            <a:ext cx="1847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35496" y="35332"/>
            <a:ext cx="12141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b="1" dirty="0" smtClean="0"/>
              <a:t>Figure </a:t>
            </a:r>
            <a:r>
              <a:rPr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9914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66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-mizukami</dc:creator>
  <cp:lastModifiedBy>t-mizukami</cp:lastModifiedBy>
  <cp:revision>6</cp:revision>
  <dcterms:created xsi:type="dcterms:W3CDTF">2014-06-30T07:29:05Z</dcterms:created>
  <dcterms:modified xsi:type="dcterms:W3CDTF">2014-09-09T00:44:22Z</dcterms:modified>
</cp:coreProperties>
</file>